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embeddings/oleObject1.bin" ContentType="application/vnd.openxmlformats-officedocument.oleObject"/>
  <Override PartName="/ppt/embeddings/oleObject2.bin" ContentType="application/vnd.openxmlformats-officedocument.oleObject"/>
  <Override PartName="/ppt/media/image1.wmf" ContentType="image/x-wmf"/>
  <Override PartName="/ppt/media/image2.wmf" ContentType="image/x-wmf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12193588" cy="6858000"/>
  <p:notesSz cx="6796088" cy="992505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A5838EB-7559-47E5-BCDB-C643C54CA257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2960"/>
                <a:tab algn="l" pos="1825560"/>
                <a:tab algn="l" pos="2738520"/>
                <a:tab algn="l" pos="3651120"/>
                <a:tab algn="l" pos="4564080"/>
                <a:tab algn="l" pos="5477040"/>
                <a:tab algn="l" pos="6389640"/>
                <a:tab algn="l" pos="7302600"/>
                <a:tab algn="l" pos="8215200"/>
                <a:tab algn="l" pos="9128160"/>
                <a:tab algn="l" pos="10040760"/>
                <a:tab algn="l" pos="10953720"/>
              </a:tabLst>
            </a:pPr>
            <a:endParaRPr b="0" lang="en-US" sz="4400" spc="-1" strike="noStrike">
              <a:solidFill>
                <a:srgbClr val="000000"/>
              </a:solidFill>
              <a:latin typeface="游ゴシック Light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105156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2960"/>
                <a:tab algn="l" pos="1825560"/>
                <a:tab algn="l" pos="2738520"/>
                <a:tab algn="l" pos="3651120"/>
                <a:tab algn="l" pos="4564080"/>
                <a:tab algn="l" pos="5477040"/>
                <a:tab algn="l" pos="6389640"/>
                <a:tab algn="l" pos="7302600"/>
                <a:tab algn="l" pos="8215200"/>
                <a:tab algn="l" pos="9128160"/>
                <a:tab algn="l" pos="10040760"/>
                <a:tab algn="l" pos="10953720"/>
              </a:tabLst>
            </a:pPr>
            <a:endParaRPr b="0" lang="en-US" sz="2800" spc="-1" strike="noStrike">
              <a:solidFill>
                <a:srgbClr val="000000"/>
              </a:solidFill>
              <a:latin typeface="游ゴシック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838080" y="4098240"/>
            <a:ext cx="105156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2960"/>
                <a:tab algn="l" pos="1825560"/>
                <a:tab algn="l" pos="2738520"/>
                <a:tab algn="l" pos="3651120"/>
                <a:tab algn="l" pos="4564080"/>
                <a:tab algn="l" pos="5477040"/>
                <a:tab algn="l" pos="6389640"/>
                <a:tab algn="l" pos="7302600"/>
                <a:tab algn="l" pos="8215200"/>
                <a:tab algn="l" pos="9128160"/>
                <a:tab algn="l" pos="10040760"/>
                <a:tab algn="l" pos="10953720"/>
              </a:tabLst>
            </a:pPr>
            <a:endParaRPr b="0" lang="en-US" sz="2800" spc="-1" strike="noStrike">
              <a:solidFill>
                <a:srgbClr val="000000"/>
              </a:solidFill>
              <a:latin typeface="游ゴシック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6626FA7-6FE5-4AA1-85D6-7A728E94C72C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2960"/>
                <a:tab algn="l" pos="1825560"/>
                <a:tab algn="l" pos="2738520"/>
                <a:tab algn="l" pos="3651120"/>
                <a:tab algn="l" pos="4564080"/>
                <a:tab algn="l" pos="5477040"/>
                <a:tab algn="l" pos="6389640"/>
                <a:tab algn="l" pos="7302600"/>
                <a:tab algn="l" pos="8215200"/>
                <a:tab algn="l" pos="9128160"/>
                <a:tab algn="l" pos="10040760"/>
                <a:tab algn="l" pos="10953720"/>
              </a:tabLst>
            </a:pPr>
            <a:endParaRPr b="0" lang="en-US" sz="4400" spc="-1" strike="noStrike">
              <a:solidFill>
                <a:srgbClr val="000000"/>
              </a:solidFill>
              <a:latin typeface="游ゴシック Light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2960"/>
                <a:tab algn="l" pos="1825560"/>
                <a:tab algn="l" pos="2738520"/>
                <a:tab algn="l" pos="3651120"/>
                <a:tab algn="l" pos="4564080"/>
                <a:tab algn="l" pos="5477040"/>
                <a:tab algn="l" pos="6389640"/>
                <a:tab algn="l" pos="7302600"/>
                <a:tab algn="l" pos="8215200"/>
                <a:tab algn="l" pos="9128160"/>
                <a:tab algn="l" pos="10040760"/>
                <a:tab algn="l" pos="10953720"/>
              </a:tabLst>
            </a:pPr>
            <a:endParaRPr b="0" lang="en-US" sz="2800" spc="-1" strike="noStrike">
              <a:solidFill>
                <a:srgbClr val="000000"/>
              </a:solidFill>
              <a:latin typeface="游ゴシック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622656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2960"/>
                <a:tab algn="l" pos="1825560"/>
                <a:tab algn="l" pos="2738520"/>
                <a:tab algn="l" pos="3651120"/>
                <a:tab algn="l" pos="4564080"/>
                <a:tab algn="l" pos="5477040"/>
                <a:tab algn="l" pos="6389640"/>
                <a:tab algn="l" pos="7302600"/>
                <a:tab algn="l" pos="8215200"/>
                <a:tab algn="l" pos="9128160"/>
                <a:tab algn="l" pos="10040760"/>
                <a:tab algn="l" pos="10953720"/>
              </a:tabLst>
            </a:pPr>
            <a:endParaRPr b="0" lang="en-US" sz="2800" spc="-1" strike="noStrike">
              <a:solidFill>
                <a:srgbClr val="000000"/>
              </a:solidFill>
              <a:latin typeface="游ゴシック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838080" y="409824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2960"/>
                <a:tab algn="l" pos="1825560"/>
                <a:tab algn="l" pos="2738520"/>
                <a:tab algn="l" pos="3651120"/>
                <a:tab algn="l" pos="4564080"/>
                <a:tab algn="l" pos="5477040"/>
                <a:tab algn="l" pos="6389640"/>
                <a:tab algn="l" pos="7302600"/>
                <a:tab algn="l" pos="8215200"/>
                <a:tab algn="l" pos="9128160"/>
                <a:tab algn="l" pos="10040760"/>
                <a:tab algn="l" pos="10953720"/>
              </a:tabLst>
            </a:pPr>
            <a:endParaRPr b="0" lang="en-US" sz="2800" spc="-1" strike="noStrike">
              <a:solidFill>
                <a:srgbClr val="000000"/>
              </a:solidFill>
              <a:latin typeface="游ゴシック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6226560" y="409824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2960"/>
                <a:tab algn="l" pos="1825560"/>
                <a:tab algn="l" pos="2738520"/>
                <a:tab algn="l" pos="3651120"/>
                <a:tab algn="l" pos="4564080"/>
                <a:tab algn="l" pos="5477040"/>
                <a:tab algn="l" pos="6389640"/>
                <a:tab algn="l" pos="7302600"/>
                <a:tab algn="l" pos="8215200"/>
                <a:tab algn="l" pos="9128160"/>
                <a:tab algn="l" pos="10040760"/>
                <a:tab algn="l" pos="10953720"/>
              </a:tabLst>
            </a:pPr>
            <a:endParaRPr b="0" lang="en-US" sz="2800" spc="-1" strike="noStrike">
              <a:solidFill>
                <a:srgbClr val="000000"/>
              </a:solidFill>
              <a:latin typeface="游ゴシック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2BFAC52-0A4D-47F6-8008-C24FDDEE14AE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2960"/>
                <a:tab algn="l" pos="1825560"/>
                <a:tab algn="l" pos="2738520"/>
                <a:tab algn="l" pos="3651120"/>
                <a:tab algn="l" pos="4564080"/>
                <a:tab algn="l" pos="5477040"/>
                <a:tab algn="l" pos="6389640"/>
                <a:tab algn="l" pos="7302600"/>
                <a:tab algn="l" pos="8215200"/>
                <a:tab algn="l" pos="9128160"/>
                <a:tab algn="l" pos="10040760"/>
                <a:tab algn="l" pos="10953720"/>
              </a:tabLst>
            </a:pPr>
            <a:endParaRPr b="0" lang="en-US" sz="4400" spc="-1" strike="noStrike">
              <a:solidFill>
                <a:srgbClr val="000000"/>
              </a:solidFill>
              <a:latin typeface="游ゴシック Light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2960"/>
                <a:tab algn="l" pos="1825560"/>
                <a:tab algn="l" pos="2738520"/>
                <a:tab algn="l" pos="3651120"/>
                <a:tab algn="l" pos="4564080"/>
                <a:tab algn="l" pos="5477040"/>
                <a:tab algn="l" pos="6389640"/>
                <a:tab algn="l" pos="7302600"/>
                <a:tab algn="l" pos="8215200"/>
                <a:tab algn="l" pos="9128160"/>
                <a:tab algn="l" pos="10040760"/>
                <a:tab algn="l" pos="10953720"/>
              </a:tabLst>
            </a:pPr>
            <a:endParaRPr b="0" lang="en-US" sz="2800" spc="-1" strike="noStrike">
              <a:solidFill>
                <a:srgbClr val="000000"/>
              </a:solidFill>
              <a:latin typeface="游ゴシック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4393440" y="182520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2960"/>
                <a:tab algn="l" pos="1825560"/>
                <a:tab algn="l" pos="2738520"/>
                <a:tab algn="l" pos="3651120"/>
                <a:tab algn="l" pos="4564080"/>
                <a:tab algn="l" pos="5477040"/>
                <a:tab algn="l" pos="6389640"/>
                <a:tab algn="l" pos="7302600"/>
                <a:tab algn="l" pos="8215200"/>
                <a:tab algn="l" pos="9128160"/>
                <a:tab algn="l" pos="10040760"/>
                <a:tab algn="l" pos="10953720"/>
              </a:tabLst>
            </a:pPr>
            <a:endParaRPr b="0" lang="en-US" sz="2800" spc="-1" strike="noStrike">
              <a:solidFill>
                <a:srgbClr val="000000"/>
              </a:solidFill>
              <a:latin typeface="游ゴシック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7949160" y="182520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2960"/>
                <a:tab algn="l" pos="1825560"/>
                <a:tab algn="l" pos="2738520"/>
                <a:tab algn="l" pos="3651120"/>
                <a:tab algn="l" pos="4564080"/>
                <a:tab algn="l" pos="5477040"/>
                <a:tab algn="l" pos="6389640"/>
                <a:tab algn="l" pos="7302600"/>
                <a:tab algn="l" pos="8215200"/>
                <a:tab algn="l" pos="9128160"/>
                <a:tab algn="l" pos="10040760"/>
                <a:tab algn="l" pos="10953720"/>
              </a:tabLst>
            </a:pPr>
            <a:endParaRPr b="0" lang="en-US" sz="2800" spc="-1" strike="noStrike">
              <a:solidFill>
                <a:srgbClr val="000000"/>
              </a:solidFill>
              <a:latin typeface="游ゴシック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838080" y="409824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2960"/>
                <a:tab algn="l" pos="1825560"/>
                <a:tab algn="l" pos="2738520"/>
                <a:tab algn="l" pos="3651120"/>
                <a:tab algn="l" pos="4564080"/>
                <a:tab algn="l" pos="5477040"/>
                <a:tab algn="l" pos="6389640"/>
                <a:tab algn="l" pos="7302600"/>
                <a:tab algn="l" pos="8215200"/>
                <a:tab algn="l" pos="9128160"/>
                <a:tab algn="l" pos="10040760"/>
                <a:tab algn="l" pos="10953720"/>
              </a:tabLst>
            </a:pPr>
            <a:endParaRPr b="0" lang="en-US" sz="2800" spc="-1" strike="noStrike">
              <a:solidFill>
                <a:srgbClr val="000000"/>
              </a:solidFill>
              <a:latin typeface="游ゴシック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4393440" y="409824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2960"/>
                <a:tab algn="l" pos="1825560"/>
                <a:tab algn="l" pos="2738520"/>
                <a:tab algn="l" pos="3651120"/>
                <a:tab algn="l" pos="4564080"/>
                <a:tab algn="l" pos="5477040"/>
                <a:tab algn="l" pos="6389640"/>
                <a:tab algn="l" pos="7302600"/>
                <a:tab algn="l" pos="8215200"/>
                <a:tab algn="l" pos="9128160"/>
                <a:tab algn="l" pos="10040760"/>
                <a:tab algn="l" pos="10953720"/>
              </a:tabLst>
            </a:pPr>
            <a:endParaRPr b="0" lang="en-US" sz="2800" spc="-1" strike="noStrike">
              <a:solidFill>
                <a:srgbClr val="000000"/>
              </a:solidFill>
              <a:latin typeface="游ゴシック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7949160" y="409824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2960"/>
                <a:tab algn="l" pos="1825560"/>
                <a:tab algn="l" pos="2738520"/>
                <a:tab algn="l" pos="3651120"/>
                <a:tab algn="l" pos="4564080"/>
                <a:tab algn="l" pos="5477040"/>
                <a:tab algn="l" pos="6389640"/>
                <a:tab algn="l" pos="7302600"/>
                <a:tab algn="l" pos="8215200"/>
                <a:tab algn="l" pos="9128160"/>
                <a:tab algn="l" pos="10040760"/>
                <a:tab algn="l" pos="10953720"/>
              </a:tabLst>
            </a:pPr>
            <a:endParaRPr b="0" lang="en-US" sz="2800" spc="-1" strike="noStrike">
              <a:solidFill>
                <a:srgbClr val="000000"/>
              </a:solidFill>
              <a:latin typeface="游ゴシック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DFB5742-A449-4327-BA05-B9D7877A4A9B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2960"/>
                <a:tab algn="l" pos="1825560"/>
                <a:tab algn="l" pos="2738520"/>
                <a:tab algn="l" pos="3651120"/>
                <a:tab algn="l" pos="4564080"/>
                <a:tab algn="l" pos="5477040"/>
                <a:tab algn="l" pos="6389640"/>
                <a:tab algn="l" pos="7302600"/>
                <a:tab algn="l" pos="8215200"/>
                <a:tab algn="l" pos="9128160"/>
                <a:tab algn="l" pos="10040760"/>
                <a:tab algn="l" pos="10953720"/>
              </a:tabLst>
            </a:pPr>
            <a:endParaRPr b="0" lang="en-US" sz="4400" spc="-1" strike="noStrike">
              <a:solidFill>
                <a:srgbClr val="000000"/>
              </a:solidFill>
              <a:latin typeface="游ゴシック Light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838080" y="1825200"/>
            <a:ext cx="10515600" cy="43513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0000"/>
              </a:lnSpc>
              <a:spcBef>
                <a:spcPts val="1001"/>
              </a:spcBef>
              <a:buNone/>
              <a:tabLst>
                <a:tab algn="l" pos="0"/>
                <a:tab algn="l" pos="912960"/>
                <a:tab algn="l" pos="1825560"/>
                <a:tab algn="l" pos="2738520"/>
                <a:tab algn="l" pos="3651120"/>
                <a:tab algn="l" pos="4564080"/>
                <a:tab algn="l" pos="5477040"/>
                <a:tab algn="l" pos="6389640"/>
                <a:tab algn="l" pos="7302600"/>
                <a:tab algn="l" pos="8215200"/>
                <a:tab algn="l" pos="9128160"/>
                <a:tab algn="l" pos="10040760"/>
                <a:tab algn="l" pos="10953720"/>
              </a:tabLst>
            </a:pPr>
            <a:endParaRPr b="0" lang="en-US" sz="2800" spc="-1" strike="noStrike">
              <a:solidFill>
                <a:srgbClr val="000000"/>
              </a:solidFill>
              <a:latin typeface="游ゴシック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D0F4FE8-A9D8-4852-8EC5-4F60604D96A8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2960"/>
                <a:tab algn="l" pos="1825560"/>
                <a:tab algn="l" pos="2738520"/>
                <a:tab algn="l" pos="3651120"/>
                <a:tab algn="l" pos="4564080"/>
                <a:tab algn="l" pos="5477040"/>
                <a:tab algn="l" pos="6389640"/>
                <a:tab algn="l" pos="7302600"/>
                <a:tab algn="l" pos="8215200"/>
                <a:tab algn="l" pos="9128160"/>
                <a:tab algn="l" pos="10040760"/>
                <a:tab algn="l" pos="10953720"/>
              </a:tabLst>
            </a:pPr>
            <a:endParaRPr b="0" lang="en-US" sz="4400" spc="-1" strike="noStrike">
              <a:solidFill>
                <a:srgbClr val="000000"/>
              </a:solidFill>
              <a:latin typeface="游ゴシック Light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1051560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2960"/>
                <a:tab algn="l" pos="1825560"/>
                <a:tab algn="l" pos="2738520"/>
                <a:tab algn="l" pos="3651120"/>
                <a:tab algn="l" pos="4564080"/>
                <a:tab algn="l" pos="5477040"/>
                <a:tab algn="l" pos="6389640"/>
                <a:tab algn="l" pos="7302600"/>
                <a:tab algn="l" pos="8215200"/>
                <a:tab algn="l" pos="9128160"/>
                <a:tab algn="l" pos="10040760"/>
                <a:tab algn="l" pos="10953720"/>
              </a:tabLst>
            </a:pPr>
            <a:endParaRPr b="0" lang="en-US" sz="2800" spc="-1" strike="noStrike">
              <a:solidFill>
                <a:srgbClr val="000000"/>
              </a:solidFill>
              <a:latin typeface="游ゴシック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025E0AB-475D-46FA-A81F-A03944B1F729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2960"/>
                <a:tab algn="l" pos="1825560"/>
                <a:tab algn="l" pos="2738520"/>
                <a:tab algn="l" pos="3651120"/>
                <a:tab algn="l" pos="4564080"/>
                <a:tab algn="l" pos="5477040"/>
                <a:tab algn="l" pos="6389640"/>
                <a:tab algn="l" pos="7302600"/>
                <a:tab algn="l" pos="8215200"/>
                <a:tab algn="l" pos="9128160"/>
                <a:tab algn="l" pos="10040760"/>
                <a:tab algn="l" pos="10953720"/>
              </a:tabLst>
            </a:pPr>
            <a:endParaRPr b="0" lang="en-US" sz="4400" spc="-1" strike="noStrike">
              <a:solidFill>
                <a:srgbClr val="000000"/>
              </a:solidFill>
              <a:latin typeface="游ゴシック Light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513144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2960"/>
                <a:tab algn="l" pos="1825560"/>
                <a:tab algn="l" pos="2738520"/>
                <a:tab algn="l" pos="3651120"/>
                <a:tab algn="l" pos="4564080"/>
                <a:tab algn="l" pos="5477040"/>
                <a:tab algn="l" pos="6389640"/>
                <a:tab algn="l" pos="7302600"/>
                <a:tab algn="l" pos="8215200"/>
                <a:tab algn="l" pos="9128160"/>
                <a:tab algn="l" pos="10040760"/>
                <a:tab algn="l" pos="10953720"/>
              </a:tabLst>
            </a:pPr>
            <a:endParaRPr b="0" lang="en-US" sz="2800" spc="-1" strike="noStrike">
              <a:solidFill>
                <a:srgbClr val="000000"/>
              </a:solidFill>
              <a:latin typeface="游ゴシック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6226560" y="1825200"/>
            <a:ext cx="513144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2960"/>
                <a:tab algn="l" pos="1825560"/>
                <a:tab algn="l" pos="2738520"/>
                <a:tab algn="l" pos="3651120"/>
                <a:tab algn="l" pos="4564080"/>
                <a:tab algn="l" pos="5477040"/>
                <a:tab algn="l" pos="6389640"/>
                <a:tab algn="l" pos="7302600"/>
                <a:tab algn="l" pos="8215200"/>
                <a:tab algn="l" pos="9128160"/>
                <a:tab algn="l" pos="10040760"/>
                <a:tab algn="l" pos="10953720"/>
              </a:tabLst>
            </a:pPr>
            <a:endParaRPr b="0" lang="en-US" sz="2800" spc="-1" strike="noStrike">
              <a:solidFill>
                <a:srgbClr val="000000"/>
              </a:solidFill>
              <a:latin typeface="游ゴシック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BAED82B-56A9-4810-A49E-738316FC2BDF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2960"/>
                <a:tab algn="l" pos="1825560"/>
                <a:tab algn="l" pos="2738520"/>
                <a:tab algn="l" pos="3651120"/>
                <a:tab algn="l" pos="4564080"/>
                <a:tab algn="l" pos="5477040"/>
                <a:tab algn="l" pos="6389640"/>
                <a:tab algn="l" pos="7302600"/>
                <a:tab algn="l" pos="8215200"/>
                <a:tab algn="l" pos="9128160"/>
                <a:tab algn="l" pos="10040760"/>
                <a:tab algn="l" pos="10953720"/>
              </a:tabLst>
            </a:pPr>
            <a:endParaRPr b="0" lang="en-US" sz="4400" spc="-1" strike="noStrike">
              <a:solidFill>
                <a:srgbClr val="000000"/>
              </a:solidFill>
              <a:latin typeface="游ゴシック Light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E89650A-C752-4BE1-8233-9308B039426A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838080" y="365040"/>
            <a:ext cx="10515600" cy="6145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lnSpc>
                <a:spcPct val="90000"/>
              </a:lnSpc>
              <a:spcBef>
                <a:spcPts val="1001"/>
              </a:spcBef>
              <a:tabLst>
                <a:tab algn="l" pos="0"/>
                <a:tab algn="l" pos="912960"/>
                <a:tab algn="l" pos="1825560"/>
                <a:tab algn="l" pos="2738520"/>
                <a:tab algn="l" pos="3651120"/>
                <a:tab algn="l" pos="4564080"/>
                <a:tab algn="l" pos="5477040"/>
                <a:tab algn="l" pos="6389640"/>
                <a:tab algn="l" pos="7302600"/>
                <a:tab algn="l" pos="8215200"/>
                <a:tab algn="l" pos="9128160"/>
                <a:tab algn="l" pos="10040760"/>
                <a:tab algn="l" pos="10953720"/>
              </a:tabLst>
            </a:pPr>
            <a:endParaRPr b="0" lang="en-US" sz="2800" spc="-1" strike="noStrike">
              <a:solidFill>
                <a:srgbClr val="000000"/>
              </a:solidFill>
              <a:latin typeface="游ゴシック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1A7183A-587C-4A8B-9392-1D8B500CE2E0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2960"/>
                <a:tab algn="l" pos="1825560"/>
                <a:tab algn="l" pos="2738520"/>
                <a:tab algn="l" pos="3651120"/>
                <a:tab algn="l" pos="4564080"/>
                <a:tab algn="l" pos="5477040"/>
                <a:tab algn="l" pos="6389640"/>
                <a:tab algn="l" pos="7302600"/>
                <a:tab algn="l" pos="8215200"/>
                <a:tab algn="l" pos="9128160"/>
                <a:tab algn="l" pos="10040760"/>
                <a:tab algn="l" pos="10953720"/>
              </a:tabLst>
            </a:pPr>
            <a:endParaRPr b="0" lang="en-US" sz="4400" spc="-1" strike="noStrike">
              <a:solidFill>
                <a:srgbClr val="000000"/>
              </a:solidFill>
              <a:latin typeface="游ゴシック Light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2960"/>
                <a:tab algn="l" pos="1825560"/>
                <a:tab algn="l" pos="2738520"/>
                <a:tab algn="l" pos="3651120"/>
                <a:tab algn="l" pos="4564080"/>
                <a:tab algn="l" pos="5477040"/>
                <a:tab algn="l" pos="6389640"/>
                <a:tab algn="l" pos="7302600"/>
                <a:tab algn="l" pos="8215200"/>
                <a:tab algn="l" pos="9128160"/>
                <a:tab algn="l" pos="10040760"/>
                <a:tab algn="l" pos="10953720"/>
              </a:tabLst>
            </a:pPr>
            <a:endParaRPr b="0" lang="en-US" sz="2800" spc="-1" strike="noStrike">
              <a:solidFill>
                <a:srgbClr val="000000"/>
              </a:solidFill>
              <a:latin typeface="游ゴシック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6226560" y="1825200"/>
            <a:ext cx="513144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2960"/>
                <a:tab algn="l" pos="1825560"/>
                <a:tab algn="l" pos="2738520"/>
                <a:tab algn="l" pos="3651120"/>
                <a:tab algn="l" pos="4564080"/>
                <a:tab algn="l" pos="5477040"/>
                <a:tab algn="l" pos="6389640"/>
                <a:tab algn="l" pos="7302600"/>
                <a:tab algn="l" pos="8215200"/>
                <a:tab algn="l" pos="9128160"/>
                <a:tab algn="l" pos="10040760"/>
                <a:tab algn="l" pos="10953720"/>
              </a:tabLst>
            </a:pPr>
            <a:endParaRPr b="0" lang="en-US" sz="2800" spc="-1" strike="noStrike">
              <a:solidFill>
                <a:srgbClr val="000000"/>
              </a:solidFill>
              <a:latin typeface="游ゴシック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838080" y="409824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2960"/>
                <a:tab algn="l" pos="1825560"/>
                <a:tab algn="l" pos="2738520"/>
                <a:tab algn="l" pos="3651120"/>
                <a:tab algn="l" pos="4564080"/>
                <a:tab algn="l" pos="5477040"/>
                <a:tab algn="l" pos="6389640"/>
                <a:tab algn="l" pos="7302600"/>
                <a:tab algn="l" pos="8215200"/>
                <a:tab algn="l" pos="9128160"/>
                <a:tab algn="l" pos="10040760"/>
                <a:tab algn="l" pos="10953720"/>
              </a:tabLst>
            </a:pPr>
            <a:endParaRPr b="0" lang="en-US" sz="2800" spc="-1" strike="noStrike">
              <a:solidFill>
                <a:srgbClr val="000000"/>
              </a:solidFill>
              <a:latin typeface="游ゴシック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9655C31-992F-4B67-B27B-5A14768BBB8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2960"/>
                <a:tab algn="l" pos="1825560"/>
                <a:tab algn="l" pos="2738520"/>
                <a:tab algn="l" pos="3651120"/>
                <a:tab algn="l" pos="4564080"/>
                <a:tab algn="l" pos="5477040"/>
                <a:tab algn="l" pos="6389640"/>
                <a:tab algn="l" pos="7302600"/>
                <a:tab algn="l" pos="8215200"/>
                <a:tab algn="l" pos="9128160"/>
                <a:tab algn="l" pos="10040760"/>
                <a:tab algn="l" pos="10953720"/>
              </a:tabLst>
            </a:pPr>
            <a:endParaRPr b="0" lang="en-US" sz="4400" spc="-1" strike="noStrike">
              <a:solidFill>
                <a:srgbClr val="000000"/>
              </a:solidFill>
              <a:latin typeface="游ゴシック Light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513144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2960"/>
                <a:tab algn="l" pos="1825560"/>
                <a:tab algn="l" pos="2738520"/>
                <a:tab algn="l" pos="3651120"/>
                <a:tab algn="l" pos="4564080"/>
                <a:tab algn="l" pos="5477040"/>
                <a:tab algn="l" pos="6389640"/>
                <a:tab algn="l" pos="7302600"/>
                <a:tab algn="l" pos="8215200"/>
                <a:tab algn="l" pos="9128160"/>
                <a:tab algn="l" pos="10040760"/>
                <a:tab algn="l" pos="10953720"/>
              </a:tabLst>
            </a:pPr>
            <a:endParaRPr b="0" lang="en-US" sz="2800" spc="-1" strike="noStrike">
              <a:solidFill>
                <a:srgbClr val="000000"/>
              </a:solidFill>
              <a:latin typeface="游ゴシック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622656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2960"/>
                <a:tab algn="l" pos="1825560"/>
                <a:tab algn="l" pos="2738520"/>
                <a:tab algn="l" pos="3651120"/>
                <a:tab algn="l" pos="4564080"/>
                <a:tab algn="l" pos="5477040"/>
                <a:tab algn="l" pos="6389640"/>
                <a:tab algn="l" pos="7302600"/>
                <a:tab algn="l" pos="8215200"/>
                <a:tab algn="l" pos="9128160"/>
                <a:tab algn="l" pos="10040760"/>
                <a:tab algn="l" pos="10953720"/>
              </a:tabLst>
            </a:pPr>
            <a:endParaRPr b="0" lang="en-US" sz="2800" spc="-1" strike="noStrike">
              <a:solidFill>
                <a:srgbClr val="000000"/>
              </a:solidFill>
              <a:latin typeface="游ゴシック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6226560" y="409824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2960"/>
                <a:tab algn="l" pos="1825560"/>
                <a:tab algn="l" pos="2738520"/>
                <a:tab algn="l" pos="3651120"/>
                <a:tab algn="l" pos="4564080"/>
                <a:tab algn="l" pos="5477040"/>
                <a:tab algn="l" pos="6389640"/>
                <a:tab algn="l" pos="7302600"/>
                <a:tab algn="l" pos="8215200"/>
                <a:tab algn="l" pos="9128160"/>
                <a:tab algn="l" pos="10040760"/>
                <a:tab algn="l" pos="10953720"/>
              </a:tabLst>
            </a:pPr>
            <a:endParaRPr b="0" lang="en-US" sz="2800" spc="-1" strike="noStrike">
              <a:solidFill>
                <a:srgbClr val="000000"/>
              </a:solidFill>
              <a:latin typeface="游ゴシック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83FA459-AF7B-4E80-B730-C9EB0133E2A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2960"/>
                <a:tab algn="l" pos="1825560"/>
                <a:tab algn="l" pos="2738520"/>
                <a:tab algn="l" pos="3651120"/>
                <a:tab algn="l" pos="4564080"/>
                <a:tab algn="l" pos="5477040"/>
                <a:tab algn="l" pos="6389640"/>
                <a:tab algn="l" pos="7302600"/>
                <a:tab algn="l" pos="8215200"/>
                <a:tab algn="l" pos="9128160"/>
                <a:tab algn="l" pos="10040760"/>
                <a:tab algn="l" pos="10953720"/>
              </a:tabLst>
            </a:pPr>
            <a:endParaRPr b="0" lang="en-US" sz="4400" spc="-1" strike="noStrike">
              <a:solidFill>
                <a:srgbClr val="000000"/>
              </a:solidFill>
              <a:latin typeface="游ゴシック Light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2960"/>
                <a:tab algn="l" pos="1825560"/>
                <a:tab algn="l" pos="2738520"/>
                <a:tab algn="l" pos="3651120"/>
                <a:tab algn="l" pos="4564080"/>
                <a:tab algn="l" pos="5477040"/>
                <a:tab algn="l" pos="6389640"/>
                <a:tab algn="l" pos="7302600"/>
                <a:tab algn="l" pos="8215200"/>
                <a:tab algn="l" pos="9128160"/>
                <a:tab algn="l" pos="10040760"/>
                <a:tab algn="l" pos="10953720"/>
              </a:tabLst>
            </a:pPr>
            <a:endParaRPr b="0" lang="en-US" sz="2800" spc="-1" strike="noStrike">
              <a:solidFill>
                <a:srgbClr val="000000"/>
              </a:solidFill>
              <a:latin typeface="游ゴシック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622656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2960"/>
                <a:tab algn="l" pos="1825560"/>
                <a:tab algn="l" pos="2738520"/>
                <a:tab algn="l" pos="3651120"/>
                <a:tab algn="l" pos="4564080"/>
                <a:tab algn="l" pos="5477040"/>
                <a:tab algn="l" pos="6389640"/>
                <a:tab algn="l" pos="7302600"/>
                <a:tab algn="l" pos="8215200"/>
                <a:tab algn="l" pos="9128160"/>
                <a:tab algn="l" pos="10040760"/>
                <a:tab algn="l" pos="10953720"/>
              </a:tabLst>
            </a:pPr>
            <a:endParaRPr b="0" lang="en-US" sz="2800" spc="-1" strike="noStrike">
              <a:solidFill>
                <a:srgbClr val="000000"/>
              </a:solidFill>
              <a:latin typeface="游ゴシック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838080" y="4098240"/>
            <a:ext cx="105156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2960"/>
                <a:tab algn="l" pos="1825560"/>
                <a:tab algn="l" pos="2738520"/>
                <a:tab algn="l" pos="3651120"/>
                <a:tab algn="l" pos="4564080"/>
                <a:tab algn="l" pos="5477040"/>
                <a:tab algn="l" pos="6389640"/>
                <a:tab algn="l" pos="7302600"/>
                <a:tab algn="l" pos="8215200"/>
                <a:tab algn="l" pos="9128160"/>
                <a:tab algn="l" pos="10040760"/>
                <a:tab algn="l" pos="10953720"/>
              </a:tabLst>
            </a:pPr>
            <a:endParaRPr b="0" lang="en-US" sz="2800" spc="-1" strike="noStrike">
              <a:solidFill>
                <a:srgbClr val="000000"/>
              </a:solidFill>
              <a:latin typeface="游ゴシック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42A364A-A9DC-4296-AC0A-4FEA850F9FF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2960"/>
                <a:tab algn="l" pos="1825560"/>
                <a:tab algn="l" pos="2738520"/>
                <a:tab algn="l" pos="3651120"/>
                <a:tab algn="l" pos="4564080"/>
                <a:tab algn="l" pos="5477040"/>
                <a:tab algn="l" pos="6389640"/>
                <a:tab algn="l" pos="7302600"/>
                <a:tab algn="l" pos="8215200"/>
                <a:tab algn="l" pos="9128160"/>
                <a:tab algn="l" pos="10040760"/>
                <a:tab algn="l" pos="1095372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游ゴシック Light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游ゴシック Light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838080" y="1825200"/>
            <a:ext cx="1051560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227160" indent="-22716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2960"/>
                <a:tab algn="l" pos="1825560"/>
                <a:tab algn="l" pos="2738520"/>
                <a:tab algn="l" pos="3651120"/>
                <a:tab algn="l" pos="4564080"/>
                <a:tab algn="l" pos="5477040"/>
                <a:tab algn="l" pos="6389640"/>
                <a:tab algn="l" pos="7302600"/>
                <a:tab algn="l" pos="8215200"/>
                <a:tab algn="l" pos="9128160"/>
                <a:tab algn="l" pos="10040760"/>
                <a:tab algn="l" pos="1095372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游ゴシック"/>
              </a:rPr>
              <a:t>Click to edit the outline text format</a:t>
            </a:r>
            <a:endParaRPr b="0" lang="en-US" sz="2800" spc="-1" strike="noStrike">
              <a:solidFill>
                <a:srgbClr val="000000"/>
              </a:solidFill>
              <a:latin typeface="游ゴシック"/>
            </a:endParaRPr>
          </a:p>
          <a:p>
            <a:pPr lvl="1" marL="684360" indent="-22716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2960"/>
                <a:tab algn="l" pos="1825560"/>
                <a:tab algn="l" pos="2738520"/>
                <a:tab algn="l" pos="3651120"/>
                <a:tab algn="l" pos="4564080"/>
                <a:tab algn="l" pos="5477040"/>
                <a:tab algn="l" pos="6389640"/>
                <a:tab algn="l" pos="7302600"/>
                <a:tab algn="l" pos="8215200"/>
                <a:tab algn="l" pos="9128160"/>
                <a:tab algn="l" pos="10040760"/>
                <a:tab algn="l" pos="1095372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游ゴシック"/>
              </a:rPr>
              <a:t>Second Outline Level</a:t>
            </a:r>
            <a:endParaRPr b="0" lang="en-US" sz="2800" spc="-1" strike="noStrike">
              <a:solidFill>
                <a:srgbClr val="000000"/>
              </a:solidFill>
              <a:latin typeface="游ゴシック"/>
            </a:endParaRPr>
          </a:p>
          <a:p>
            <a:pPr lvl="2" marL="1141560" indent="-22716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2960"/>
                <a:tab algn="l" pos="1825560"/>
                <a:tab algn="l" pos="2738520"/>
                <a:tab algn="l" pos="3651120"/>
                <a:tab algn="l" pos="4564080"/>
                <a:tab algn="l" pos="5477040"/>
                <a:tab algn="l" pos="6389640"/>
                <a:tab algn="l" pos="7302600"/>
                <a:tab algn="l" pos="8215200"/>
                <a:tab algn="l" pos="9128160"/>
                <a:tab algn="l" pos="10040760"/>
                <a:tab algn="l" pos="1095372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游ゴシック"/>
              </a:rPr>
              <a:t>Third Outline Level</a:t>
            </a:r>
            <a:endParaRPr b="0" lang="en-US" sz="2800" spc="-1" strike="noStrike">
              <a:solidFill>
                <a:srgbClr val="000000"/>
              </a:solidFill>
              <a:latin typeface="游ゴシック"/>
            </a:endParaRPr>
          </a:p>
          <a:p>
            <a:pPr lvl="3" marL="1598760" indent="-22716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2960"/>
                <a:tab algn="l" pos="1825560"/>
                <a:tab algn="l" pos="2738520"/>
                <a:tab algn="l" pos="3651120"/>
                <a:tab algn="l" pos="4564080"/>
                <a:tab algn="l" pos="5477040"/>
                <a:tab algn="l" pos="6389640"/>
                <a:tab algn="l" pos="7302600"/>
                <a:tab algn="l" pos="8215200"/>
                <a:tab algn="l" pos="9128160"/>
                <a:tab algn="l" pos="10040760"/>
                <a:tab algn="l" pos="1095372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游ゴシック"/>
              </a:rPr>
              <a:t>Fourth Outline Level</a:t>
            </a:r>
            <a:endParaRPr b="0" lang="en-US" sz="2800" spc="-1" strike="noStrike">
              <a:solidFill>
                <a:srgbClr val="000000"/>
              </a:solidFill>
              <a:latin typeface="游ゴシック"/>
            </a:endParaRPr>
          </a:p>
          <a:p>
            <a:pPr lvl="4" marL="2055960" indent="-22716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2960"/>
                <a:tab algn="l" pos="1825560"/>
                <a:tab algn="l" pos="2738520"/>
                <a:tab algn="l" pos="3651120"/>
                <a:tab algn="l" pos="4564080"/>
                <a:tab algn="l" pos="5477040"/>
                <a:tab algn="l" pos="6389640"/>
                <a:tab algn="l" pos="7302600"/>
                <a:tab algn="l" pos="8215200"/>
                <a:tab algn="l" pos="9128160"/>
                <a:tab algn="l" pos="10040760"/>
                <a:tab algn="l" pos="1095372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游ゴシック"/>
              </a:rPr>
              <a:t>Fifth Outline Level</a:t>
            </a:r>
            <a:endParaRPr b="0" lang="en-US" sz="2800" spc="-1" strike="noStrike">
              <a:solidFill>
                <a:srgbClr val="000000"/>
              </a:solidFill>
              <a:latin typeface="游ゴシック"/>
            </a:endParaRPr>
          </a:p>
          <a:p>
            <a:pPr lvl="5" marL="2055960" indent="-22716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2960"/>
                <a:tab algn="l" pos="1825560"/>
                <a:tab algn="l" pos="2738520"/>
                <a:tab algn="l" pos="3651120"/>
                <a:tab algn="l" pos="4564080"/>
                <a:tab algn="l" pos="5477040"/>
                <a:tab algn="l" pos="6389640"/>
                <a:tab algn="l" pos="7302600"/>
                <a:tab algn="l" pos="8215200"/>
                <a:tab algn="l" pos="9128160"/>
                <a:tab algn="l" pos="10040760"/>
                <a:tab algn="l" pos="1095372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游ゴシック"/>
              </a:rPr>
              <a:t>Sixth Outline Level</a:t>
            </a:r>
            <a:endParaRPr b="0" lang="en-US" sz="2800" spc="-1" strike="noStrike">
              <a:solidFill>
                <a:srgbClr val="000000"/>
              </a:solidFill>
              <a:latin typeface="游ゴシック"/>
            </a:endParaRPr>
          </a:p>
          <a:p>
            <a:pPr lvl="6" marL="2055960" indent="-22716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2960"/>
                <a:tab algn="l" pos="1825560"/>
                <a:tab algn="l" pos="2738520"/>
                <a:tab algn="l" pos="3651120"/>
                <a:tab algn="l" pos="4564080"/>
                <a:tab algn="l" pos="5477040"/>
                <a:tab algn="l" pos="6389640"/>
                <a:tab algn="l" pos="7302600"/>
                <a:tab algn="l" pos="8215200"/>
                <a:tab algn="l" pos="9128160"/>
                <a:tab algn="l" pos="10040760"/>
                <a:tab algn="l" pos="1095372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游ゴシック"/>
              </a:rPr>
              <a:t>Seventh Outline Level</a:t>
            </a:r>
            <a:endParaRPr b="0" lang="en-US" sz="2800" spc="-1" strike="noStrike">
              <a:solidFill>
                <a:srgbClr val="000000"/>
              </a:solidFill>
              <a:latin typeface="游ゴシック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838080" y="6356520"/>
            <a:ext cx="274320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ja-JP" sz="1200" spc="-1" strike="noStrike">
                <a:solidFill>
                  <a:srgbClr val="898989"/>
                </a:solidFill>
                <a:latin typeface="游ゴシック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1200" spc="-1" strike="noStrike">
                <a:solidFill>
                  <a:srgbClr val="898989"/>
                </a:solidFill>
                <a:latin typeface="游ゴシック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游ゴシック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4038480" y="6356520"/>
            <a:ext cx="411480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游ゴシック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8610480" y="6356520"/>
            <a:ext cx="274320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ja-JP" sz="1200" spc="-1" strike="noStrike">
                <a:solidFill>
                  <a:srgbClr val="898989"/>
                </a:solidFill>
                <a:latin typeface="游ゴシック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5C1FE731-588C-46CB-9221-38FDD996DB91}" type="slidenum">
              <a:rPr b="0" lang="ja-JP" sz="1200" spc="-1" strike="noStrike">
                <a:solidFill>
                  <a:srgbClr val="898989"/>
                </a:solidFill>
                <a:latin typeface="游ゴシック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游ゴシック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oleObject" Target="../embeddings/oleObject1.bin"/><Relationship Id="rId2" Type="http://schemas.openxmlformats.org/officeDocument/2006/relationships/image" Target="../media/image1.wmf"/><Relationship Id="rId3" Type="http://schemas.openxmlformats.org/officeDocument/2006/relationships/oleObject" Target="../embeddings/oleObject2.bin"/><Relationship Id="rId4" Type="http://schemas.openxmlformats.org/officeDocument/2006/relationships/image" Target="../media/image2.wmf"/><Relationship Id="rId5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1" name="オブジェクト 1"/>
          <p:cNvGraphicFramePr/>
          <p:nvPr/>
        </p:nvGraphicFramePr>
        <p:xfrm>
          <a:off x="1098720" y="1685880"/>
          <a:ext cx="5248080" cy="3486240"/>
        </p:xfrm>
        <a:graphic>
          <a:graphicData uri="http://schemas.openxmlformats.org/presentationml/2006/ole">
            <p:oleObj r:id="rId1" spid="">
              <p:embed/>
              <p:pic>
                <p:nvPicPr>
                  <p:cNvPr id="42" name="オブジェクト 1" descr=""/>
                  <p:cNvPicPr/>
                  <p:nvPr/>
                </p:nvPicPr>
                <p:blipFill>
                  <a:blip r:embed="rId2"/>
                  <a:stretch/>
                </p:blipFill>
                <p:spPr>
                  <a:xfrm>
                    <a:off x="1098720" y="1685880"/>
                    <a:ext cx="5248080" cy="348624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43" name="テキスト ボックス 5"/>
          <p:cNvSpPr/>
          <p:nvPr/>
        </p:nvSpPr>
        <p:spPr>
          <a:xfrm>
            <a:off x="2063880" y="5170320"/>
            <a:ext cx="32065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1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Total irAE </a:t>
            </a:r>
            <a:r>
              <a:rPr b="0" lang="en-US" sz="1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n</a:t>
            </a:r>
            <a:r>
              <a:rPr b="0" lang="ja-JP" sz="1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umber</a:t>
            </a:r>
            <a:r>
              <a:rPr b="0" lang="en-US" sz="1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s</a:t>
            </a:r>
            <a:r>
              <a:rPr b="0" lang="ja-JP" sz="1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per patients</a:t>
            </a:r>
            <a:endParaRPr b="0" lang="en-US" sz="1800" spc="-1" strike="noStrike">
              <a:solidFill>
                <a:srgbClr val="000000"/>
              </a:solidFill>
              <a:latin typeface="游ゴシック"/>
            </a:endParaRPr>
          </a:p>
        </p:txBody>
      </p:sp>
      <p:sp>
        <p:nvSpPr>
          <p:cNvPr id="44" name="テキスト ボックス 6"/>
          <p:cNvSpPr/>
          <p:nvPr/>
        </p:nvSpPr>
        <p:spPr>
          <a:xfrm rot="16200000">
            <a:off x="326160" y="3227400"/>
            <a:ext cx="173052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2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Total</a:t>
            </a:r>
            <a:r>
              <a:rPr b="0" lang="en-US" sz="2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</a:t>
            </a:r>
            <a:r>
              <a:rPr b="0" lang="ja-JP" sz="2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patients</a:t>
            </a:r>
            <a:endParaRPr b="0" lang="en-US" sz="2000" spc="-1" strike="noStrike">
              <a:solidFill>
                <a:srgbClr val="000000"/>
              </a:solidFill>
              <a:latin typeface="游ゴシック"/>
            </a:endParaRPr>
          </a:p>
        </p:txBody>
      </p:sp>
      <p:sp>
        <p:nvSpPr>
          <p:cNvPr id="45" name="テキスト ボックス 5"/>
          <p:cNvSpPr/>
          <p:nvPr/>
        </p:nvSpPr>
        <p:spPr>
          <a:xfrm>
            <a:off x="6842160" y="5170320"/>
            <a:ext cx="40878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Days from</a:t>
            </a:r>
            <a:r>
              <a:rPr b="0" lang="ja-JP" sz="1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</a:t>
            </a:r>
            <a:r>
              <a:rPr b="0" lang="en-US" sz="1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first</a:t>
            </a:r>
            <a:r>
              <a:rPr b="0" lang="ja-JP" sz="1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</a:t>
            </a:r>
            <a:r>
              <a:rPr b="0" lang="en-US" sz="1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ICIs combination</a:t>
            </a:r>
            <a:r>
              <a:rPr b="0" lang="ja-JP" sz="1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</a:t>
            </a:r>
            <a:r>
              <a:rPr b="0" lang="en-US" sz="1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therapy</a:t>
            </a:r>
            <a:endParaRPr b="0" lang="en-US" sz="1800" spc="-1" strike="noStrike">
              <a:solidFill>
                <a:srgbClr val="000000"/>
              </a:solidFill>
              <a:latin typeface="游ゴシック"/>
            </a:endParaRPr>
          </a:p>
        </p:txBody>
      </p:sp>
      <p:graphicFrame>
        <p:nvGraphicFramePr>
          <p:cNvPr id="46" name="オブジェクト 8"/>
          <p:cNvGraphicFramePr/>
          <p:nvPr/>
        </p:nvGraphicFramePr>
        <p:xfrm>
          <a:off x="6235560" y="1684440"/>
          <a:ext cx="5248440" cy="3485880"/>
        </p:xfrm>
        <a:graphic>
          <a:graphicData uri="http://schemas.openxmlformats.org/presentationml/2006/ole">
            <p:oleObj r:id="rId3" spid="">
              <p:embed/>
              <p:pic>
                <p:nvPicPr>
                  <p:cNvPr id="47" name="オブジェクト 8" descr=""/>
                  <p:cNvPicPr/>
                  <p:nvPr/>
                </p:nvPicPr>
                <p:blipFill>
                  <a:blip r:embed="rId4"/>
                  <a:stretch/>
                </p:blipFill>
                <p:spPr>
                  <a:xfrm>
                    <a:off x="6235560" y="1684440"/>
                    <a:ext cx="5248440" cy="348588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48" name="テキスト ボックス 6"/>
          <p:cNvSpPr/>
          <p:nvPr/>
        </p:nvSpPr>
        <p:spPr>
          <a:xfrm rot="16200000">
            <a:off x="5379120" y="3227400"/>
            <a:ext cx="173052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2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Total</a:t>
            </a:r>
            <a:r>
              <a:rPr b="0" lang="en-US" sz="2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</a:t>
            </a:r>
            <a:r>
              <a:rPr b="0" lang="ja-JP" sz="2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patients</a:t>
            </a:r>
            <a:endParaRPr b="0" lang="en-US" sz="2000" spc="-1" strike="noStrike">
              <a:solidFill>
                <a:srgbClr val="000000"/>
              </a:solidFill>
              <a:latin typeface="游ゴシック"/>
            </a:endParaRPr>
          </a:p>
        </p:txBody>
      </p:sp>
      <p:sp>
        <p:nvSpPr>
          <p:cNvPr id="49" name="テキスト ボックス 14"/>
          <p:cNvSpPr/>
          <p:nvPr/>
        </p:nvSpPr>
        <p:spPr>
          <a:xfrm>
            <a:off x="992160" y="863640"/>
            <a:ext cx="44460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</a:t>
            </a:r>
            <a:endParaRPr b="0" lang="en-US" sz="2400" spc="-1" strike="noStrike">
              <a:solidFill>
                <a:srgbClr val="000000"/>
              </a:solidFill>
              <a:latin typeface="游ゴシック"/>
            </a:endParaRPr>
          </a:p>
        </p:txBody>
      </p:sp>
      <p:sp>
        <p:nvSpPr>
          <p:cNvPr id="50" name="テキスト ボックス 14"/>
          <p:cNvSpPr/>
          <p:nvPr/>
        </p:nvSpPr>
        <p:spPr>
          <a:xfrm>
            <a:off x="6000840" y="863640"/>
            <a:ext cx="44424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b</a:t>
            </a:r>
            <a:endParaRPr b="0" lang="en-US" sz="2400" spc="-1" strike="noStrike">
              <a:solidFill>
                <a:srgbClr val="000000"/>
              </a:solidFill>
              <a:latin typeface="游ゴシック"/>
            </a:endParaRPr>
          </a:p>
        </p:txBody>
      </p:sp>
      <p:sp>
        <p:nvSpPr>
          <p:cNvPr id="51" name="テキスト ボックス 1"/>
          <p:cNvSpPr/>
          <p:nvPr/>
        </p:nvSpPr>
        <p:spPr>
          <a:xfrm>
            <a:off x="10932480" y="4670280"/>
            <a:ext cx="110268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(months)</a:t>
            </a:r>
            <a:endParaRPr b="0" lang="en-US" sz="2000" spc="-1" strike="noStrike">
              <a:solidFill>
                <a:srgbClr val="000000"/>
              </a:solidFill>
              <a:latin typeface="游ゴシック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45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21-01-25T07:34:11Z</dcterms:created>
  <dc:creator>山田 穂高</dc:creator>
  <dc:description/>
  <dc:language>en-US</dc:language>
  <cp:lastModifiedBy>山田 穂高</cp:lastModifiedBy>
  <cp:lastPrinted>2022-03-01T07:16:33Z</cp:lastPrinted>
  <dcterms:modified xsi:type="dcterms:W3CDTF">2022-03-01T07:19:55Z</dcterms:modified>
  <cp:revision>27</cp:revision>
  <dc:subject/>
  <dc:title>PowerPoint プレゼンテーション</dc:title>
</cp:coreProperties>
</file>